
<file path=[Content_Types].xml><?xml version="1.0" encoding="utf-8"?>
<Types xmlns="http://schemas.openxmlformats.org/package/2006/content-types">
  <Default Extension="fntdata" ContentType="application/x-fontdata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embeddedFontLst>
    <p:embeddedFont>
      <p:font typeface="Arial Black" panose="020B0A04020102020204" pitchFamily="34" charset="0"/>
      <p:regular r:id="rId4"/>
      <p:bold r:id="rId5"/>
    </p:embeddedFont>
    <p:embeddedFont>
      <p:font typeface="Calibri" panose="020F0502020204030204" pitchFamily="34" charset="0"/>
      <p:regular r:id="rId6"/>
      <p:bold r:id="rId7"/>
      <p:italic r:id="rId8"/>
      <p:boldItalic r:id="rId9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0" roundtripDataSignature="AMtx7mjkBWHc9Rrp7PszBL+/kElyWodDH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CF9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144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presProps" Target="presProps.xml"/><Relationship Id="rId5" Type="http://schemas.openxmlformats.org/officeDocument/2006/relationships/font" Target="fonts/font2.fntdata"/><Relationship Id="rId10" Type="http://customschemas.google.com/relationships/presentationmetadata" Target="metadata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8" name="Google Shape;8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5"/>
          <p:cNvSpPr txBox="1"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5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9pPr>
          </a:lstStyle>
          <a:p>
            <a:endParaRPr/>
          </a:p>
        </p:txBody>
      </p:sp>
      <p:sp>
        <p:nvSpPr>
          <p:cNvPr id="20" name="Google Shape;20;p5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5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4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2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342900" lvl="0" indent="-257175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685800" lvl="1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028700" lvl="2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371600" lvl="3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714500" lvl="4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057400" lvl="5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2400300" lvl="6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743200" lvl="7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086100" lvl="8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6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6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342900" lvl="0" indent="-17145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1800">
                <a:solidFill>
                  <a:srgbClr val="888888"/>
                </a:solidFill>
              </a:defRPr>
            </a:lvl1pPr>
            <a:lvl2pPr marL="685800" lvl="1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1500">
                <a:solidFill>
                  <a:srgbClr val="888888"/>
                </a:solidFill>
              </a:defRPr>
            </a:lvl2pPr>
            <a:lvl3pPr marL="1028700" lvl="2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350">
                <a:solidFill>
                  <a:srgbClr val="888888"/>
                </a:solidFill>
              </a:defRPr>
            </a:lvl3pPr>
            <a:lvl4pPr marL="1371600" lvl="3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4pPr>
            <a:lvl5pPr marL="1714500" lvl="4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5pPr>
            <a:lvl6pPr marL="2057400" lvl="5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6pPr>
            <a:lvl7pPr marL="2400300" lvl="6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7pPr>
            <a:lvl8pPr marL="2743200" lvl="7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8pPr>
            <a:lvl9pPr marL="3086100" lvl="8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342900" lvl="0" indent="-257175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685800" lvl="1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028700" lvl="2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371600" lvl="3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714500" lvl="4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057400" lvl="5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2400300" lvl="6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743200" lvl="7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086100" lvl="8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7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342900" lvl="0" indent="-257175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685800" lvl="1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028700" lvl="2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371600" lvl="3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714500" lvl="4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057400" lvl="5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2400300" lvl="6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743200" lvl="7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086100" lvl="8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8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8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342900" lvl="0" indent="-17145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685800" lvl="1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028700" lvl="2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371600" lvl="3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1714500" lvl="4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057400" lvl="5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2400300" lvl="6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2743200" lvl="7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3086100" lvl="8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39" name="Google Shape;39;p8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342900" lvl="0" indent="-257175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685800" lvl="1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028700" lvl="2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371600" lvl="3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714500" lvl="4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057400" lvl="5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2400300" lvl="6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743200" lvl="7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086100" lvl="8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8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342900" lvl="0" indent="-17145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685800" lvl="1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028700" lvl="2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371600" lvl="3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1714500" lvl="4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057400" lvl="5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2400300" lvl="6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2743200" lvl="7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3086100" lvl="8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1" name="Google Shape;41;p8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342900" lvl="0" indent="-257175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685800" lvl="1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028700" lvl="2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371600" lvl="3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714500" lvl="4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057400" lvl="5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2400300" lvl="6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743200" lvl="7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086100" lvl="8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1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342900" lvl="0" indent="-32385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2400"/>
            </a:lvl1pPr>
            <a:lvl2pPr marL="685800" lvl="1" indent="-3048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100"/>
            </a:lvl2pPr>
            <a:lvl3pPr marL="1028700" lvl="2" indent="-2857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1800"/>
            </a:lvl3pPr>
            <a:lvl4pPr marL="1371600" lvl="3" indent="-2667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4pPr>
            <a:lvl5pPr marL="1714500" lvl="4" indent="-2667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5pPr>
            <a:lvl6pPr marL="2057400" lvl="5" indent="-2667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6pPr>
            <a:lvl7pPr marL="2400300" lvl="6" indent="-2667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7pPr>
            <a:lvl8pPr marL="2743200" lvl="7" indent="-2667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8pPr>
            <a:lvl9pPr marL="3086100" lvl="8" indent="-2667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342900" lvl="0" indent="-17145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685800" lvl="1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028700" lvl="2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371600" lvl="3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1714500" lvl="4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057400" lvl="5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2400300" lvl="6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2743200" lvl="7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3086100" lvl="8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2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2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342900" lvl="0" indent="-17145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685800" lvl="1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028700" lvl="2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371600" lvl="3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1714500" lvl="4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057400" lvl="5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2400300" lvl="6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2743200" lvl="7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3086100" lvl="8" indent="-1714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3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342900" lvl="0" indent="-257175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685800" lvl="1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028700" lvl="2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371600" lvl="3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714500" lvl="4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057400" lvl="5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2400300" lvl="6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743200" lvl="7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3086100" lvl="8" indent="-25717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3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05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CF9F6"/>
        </a:solidFill>
        <a:effectLst/>
      </p:bgPr>
    </p:bg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Google Shape;90;p2" descr="A white text on an orange background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8458200" y="6172200"/>
            <a:ext cx="685800" cy="685800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Google Shape;91;p2"/>
          <p:cNvSpPr txBox="1"/>
          <p:nvPr/>
        </p:nvSpPr>
        <p:spPr>
          <a:xfrm>
            <a:off x="113896" y="6211346"/>
            <a:ext cx="7327900" cy="2134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1413" tIns="25706" rIns="51413" bIns="25706" anchor="t" anchorCtr="0">
            <a:spAutoFit/>
          </a:bodyPr>
          <a:lstStyle/>
          <a:p>
            <a:pPr>
              <a:buClr>
                <a:srgbClr val="F29806"/>
              </a:buClr>
              <a:buSzPts val="1100"/>
            </a:pPr>
            <a:r>
              <a:rPr lang="en-GB" sz="1050" b="1" dirty="0">
                <a:solidFill>
                  <a:schemeClr val="tx1"/>
                </a:solidFill>
              </a:rPr>
              <a:t>Gonzalez Acera M</a:t>
            </a:r>
            <a:r>
              <a:rPr lang="en-GB" sz="1050" dirty="0">
                <a:solidFill>
                  <a:schemeClr val="tx1"/>
                </a:solidFill>
              </a:rPr>
              <a:t>, et al. Gut 2025. DOI: 10.1136/gut-2024-333729</a:t>
            </a:r>
            <a:endParaRPr sz="1050" dirty="0">
              <a:solidFill>
                <a:schemeClr val="tx1"/>
              </a:solidFill>
            </a:endParaRPr>
          </a:p>
        </p:txBody>
      </p:sp>
      <p:sp>
        <p:nvSpPr>
          <p:cNvPr id="92" name="Google Shape;92;p2"/>
          <p:cNvSpPr/>
          <p:nvPr/>
        </p:nvSpPr>
        <p:spPr>
          <a:xfrm>
            <a:off x="0" y="0"/>
            <a:ext cx="9144000" cy="806450"/>
          </a:xfrm>
          <a:prstGeom prst="rect">
            <a:avLst/>
          </a:prstGeom>
          <a:solidFill>
            <a:srgbClr val="EE9544"/>
          </a:solidFill>
          <a:ln>
            <a:noFill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/>
            <a:endParaRPr sz="1350">
              <a:solidFill>
                <a:srgbClr val="F29806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3" name="Google Shape;93;p2"/>
          <p:cNvSpPr txBox="1"/>
          <p:nvPr/>
        </p:nvSpPr>
        <p:spPr>
          <a:xfrm>
            <a:off x="196850" y="118551"/>
            <a:ext cx="8750300" cy="6232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spAutoFit/>
          </a:bodyPr>
          <a:lstStyle/>
          <a:p>
            <a:r>
              <a:rPr lang="en-GB" sz="1800" dirty="0">
                <a:solidFill>
                  <a:schemeClr val="lt1"/>
                </a:solidFill>
              </a:rPr>
              <a:t>Integrated multi-model analysis of intestinal inflammation exposes key molecular features of preclinical and clinical IBD</a:t>
            </a:r>
            <a:endParaRPr sz="1050" dirty="0"/>
          </a:p>
        </p:txBody>
      </p:sp>
      <p:sp>
        <p:nvSpPr>
          <p:cNvPr id="94" name="Google Shape;94;p2"/>
          <p:cNvSpPr txBox="1"/>
          <p:nvPr/>
        </p:nvSpPr>
        <p:spPr>
          <a:xfrm>
            <a:off x="1245398" y="6583134"/>
            <a:ext cx="1136650" cy="2308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spAutoFit/>
          </a:bodyPr>
          <a:lstStyle/>
          <a:p>
            <a:r>
              <a:rPr lang="en-GB" sz="105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gut.bmj.com</a:t>
            </a:r>
            <a:endParaRPr sz="1050"/>
          </a:p>
        </p:txBody>
      </p:sp>
      <p:pic>
        <p:nvPicPr>
          <p:cNvPr id="95" name="Google Shape;95;p2"/>
          <p:cNvPicPr preferRelativeResize="0"/>
          <p:nvPr/>
        </p:nvPicPr>
        <p:blipFill rotWithShape="1">
          <a:blip r:embed="rId4">
            <a:alphaModFix/>
          </a:blip>
          <a:srcRect l="30721" t="82930" r="64094" b="11661"/>
          <a:stretch/>
        </p:blipFill>
        <p:spPr>
          <a:xfrm>
            <a:off x="113896" y="6508750"/>
            <a:ext cx="495299" cy="323022"/>
          </a:xfrm>
          <a:prstGeom prst="rect">
            <a:avLst/>
          </a:prstGeom>
          <a:noFill/>
          <a:ln>
            <a:noFill/>
          </a:ln>
        </p:spPr>
      </p:pic>
      <p:sp>
        <p:nvSpPr>
          <p:cNvPr id="96" name="Google Shape;96;p2"/>
          <p:cNvSpPr txBox="1"/>
          <p:nvPr/>
        </p:nvSpPr>
        <p:spPr>
          <a:xfrm>
            <a:off x="2516601" y="6583134"/>
            <a:ext cx="1003300" cy="2308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spAutoFit/>
          </a:bodyPr>
          <a:lstStyle/>
          <a:p>
            <a:r>
              <a:rPr lang="en-GB" sz="105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@Gut_BMJ</a:t>
            </a:r>
            <a:endParaRPr sz="1050"/>
          </a:p>
        </p:txBody>
      </p:sp>
      <p:pic>
        <p:nvPicPr>
          <p:cNvPr id="97" name="Google Shape;97;p2" descr="About BSG - BSG 2024 Live!"/>
          <p:cNvPicPr preferRelativeResize="0"/>
          <p:nvPr/>
        </p:nvPicPr>
        <p:blipFill rotWithShape="1">
          <a:blip r:embed="rId5">
            <a:alphaModFix/>
          </a:blip>
          <a:srcRect t="1184" r="60381"/>
          <a:stretch/>
        </p:blipFill>
        <p:spPr>
          <a:xfrm>
            <a:off x="743748" y="6541066"/>
            <a:ext cx="367096" cy="271784"/>
          </a:xfrm>
          <a:prstGeom prst="rect">
            <a:avLst/>
          </a:prstGeom>
          <a:noFill/>
          <a:ln>
            <a:noFill/>
          </a:ln>
        </p:spPr>
      </p:pic>
      <p:pic>
        <p:nvPicPr>
          <p:cNvPr id="98" name="Google Shape;98;p2" descr="About Twitter | Our logo, brand guidelines, and Tweet tools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429135" y="6616700"/>
            <a:ext cx="143498" cy="146730"/>
          </a:xfrm>
          <a:prstGeom prst="rect">
            <a:avLst/>
          </a:prstGeom>
          <a:noFill/>
          <a:ln>
            <a:noFill/>
          </a:ln>
        </p:spPr>
      </p:pic>
      <p:pic>
        <p:nvPicPr>
          <p:cNvPr id="2" name="Grafik 1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35041"/>
            <a:ext cx="9144000" cy="5187917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Arial</vt:lpstr>
      <vt:lpstr>Arial Black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ut: Author Instructions for Visual Abstracts (VAs)</dc:title>
  <dc:creator>Anna Savage</dc:creator>
  <cp:lastModifiedBy>Angelica Therese Adel</cp:lastModifiedBy>
  <cp:revision>9</cp:revision>
  <dcterms:created xsi:type="dcterms:W3CDTF">2024-02-16T09:26:22Z</dcterms:created>
  <dcterms:modified xsi:type="dcterms:W3CDTF">2025-03-11T13:51:58Z</dcterms:modified>
</cp:coreProperties>
</file>